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6" r:id="rId2"/>
    <p:sldId id="280" r:id="rId3"/>
    <p:sldId id="281" r:id="rId4"/>
    <p:sldId id="282" r:id="rId5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3E90E474-AA40-0547-8148-23EDFA8C7F40}">
          <p14:sldIdLst>
            <p14:sldId id="276"/>
            <p14:sldId id="280"/>
            <p14:sldId id="281"/>
            <p14:sldId id="282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922" autoAdjust="0"/>
  </p:normalViewPr>
  <p:slideViewPr>
    <p:cSldViewPr snapToGrid="0" snapToObjects="1" showGuides="1">
      <p:cViewPr>
        <p:scale>
          <a:sx n="100" d="100"/>
          <a:sy n="100" d="100"/>
        </p:scale>
        <p:origin x="-1744" y="16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A157D-C987-9647-8EFA-79CB5430D7C9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CCF4A7-2F8A-0B4A-9B39-AE0D624E8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40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67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175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86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23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123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97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81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960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315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655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252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0415F-2263-9340-B64C-2F0F0E394398}" type="datetimeFigureOut">
              <a:rPr kumimoji="1" lang="ja-JP" altLang="en-US" smtClean="0"/>
              <a:t>14/01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127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504661" y="403749"/>
            <a:ext cx="5848677" cy="7971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altLang="ja-JP" sz="800" dirty="0" smtClean="0">
                <a:latin typeface="Courier"/>
                <a:cs typeface="Courier"/>
              </a:rPr>
              <a:t>MdSSK1       </a:t>
            </a:r>
            <a:r>
              <a:rPr lang="cs-CZ" altLang="ja-JP" sz="800" dirty="0">
                <a:latin typeface="Courier"/>
                <a:cs typeface="Courier"/>
              </a:rPr>
              <a:t>1 MSTEEKKIEDPASSASATEENKSEASASASASASEAPSTTENDGAEKKKISLKTSDGEVFEIDGDIAMQF     70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1       1 MSTEKEDIEAPDATDTEEEAQL----------------ATEN--YESKKISLKTSDGEIFEIDENVAMQF     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2       1 MSTEEKKIEDPASSASATEENKNE------ASASEAPSTTENDGGEKKKISLKTSDGEVFEIDGDIAMQF     64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SSK1      1 MSAE-------------EEKND----------------AAPD--GEKTKISLKTSEGEVFEIEENVAMEF     39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PSK1      1 --------------------------------------MSSE-----RKITLKSSDGETFEVDEAVALES     2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iSSK1       1 -------------------------------------MASEK-----KMVTLKSNDDQEFQVEEAAVIQS     28</a:t>
            </a:r>
          </a:p>
          <a:p>
            <a:r>
              <a:rPr lang="cs-CZ" altLang="ja-JP" sz="800" dirty="0">
                <a:latin typeface="Courier"/>
                <a:cs typeface="Courier"/>
              </a:rPr>
              <a:t>PhSSK1       1 -------------------------------------MASEK-----KMVTLKSNDDQEFQVEEAAVIQS     2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hSSK1       1 -----------------------------------ASEVAEK-----KTLTLTSSDGQDFTVSESGGCLS     3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         1 --------------------------------------MSAK------KIVLKSSDGESFEVEEAVALES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         1 --------------------------------------MSTV-----RKITLKSSDGENFEIDEAVALES     2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3         1 ------------------------------------MAETKK------MIILKSSDGESFEVEEAVAVES     2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4         1 ------------------------------------MAETKK------MIILKSSDGESFEIEEAVAVKS     2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5         1 ---------------------------------------MST------KIMLKSSDGKSFEIDEDVARKS     2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6         1 -------------------------------------------------MMIKG----------------      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7         1 --------------------------------------MSTK------KIMLKSSDGKMFEIEEETARQC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8         1 --------------------------------------MSTK------KIMLKSSEGKTFEIEEETARQC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9         1 --------------------------------------MSTK------KIILKSSDGHSFEVEEEAARQC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0        1 --------------------------------------MSTK------KIILKSSDGHSFEVEEEAACQC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1        1 --------------------------------------MSSK------MIVLMSSDGQSFEVEEAVAIQS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2        1 --------------------------------------MSSK------MIVLMSSDGQSFEVEEAVAIQS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3        1 ---------------------------------------MSK------MVMLLSSDGESFQVEEAVAVQS     2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4        1 --------------------------------------MSSN------KIVLSSSDGESFEVEEAVARKL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5        1 --------------------------------------MSSN------KIVLTSSDGESFQVEEVVARKL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6        1 --------------------------------------MSSN------KIVLTSSDDESFEVEEAVARKL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7        1 --------------------------------------MSSK------KIVLTSSDDECFEIDEAVARKM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8        1 -------------MASSSEEIVSAGESSEIEEAVASLTMSSN------KILLTSSDGESFEIDEAVARKF     5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9        1 --------------------------------------MSSK------KIVLTSSDGESFKVEEVVARKL     2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0        1 --------------------------------MSEGDLAVMKPETMKSYIWLQTADGSIQQVEQEVAMFC     3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1        1 --------------------------------MSEGEMAIIKPEMMKSYIWLETADGSIQQVEQEVAMFC     38</a:t>
            </a:r>
          </a:p>
          <a:p>
            <a:r>
              <a:rPr lang="cs-CZ" altLang="ja-JP" sz="800" dirty="0">
                <a:latin typeface="Courier"/>
                <a:cs typeface="Courier"/>
              </a:rPr>
              <a:t>OSK1         1 --------------------------------------MAAEG--EKKMITLKSSDGEEFEVEEAVAMES     30</a:t>
            </a:r>
          </a:p>
          <a:p>
            <a:r>
              <a:rPr lang="cs-CZ" altLang="ja-JP" sz="800" dirty="0">
                <a:latin typeface="Courier"/>
                <a:cs typeface="Courier"/>
              </a:rPr>
              <a:t>                                                     .. .      .. ....... ..... ..   </a:t>
            </a:r>
          </a:p>
          <a:p>
            <a:endParaRPr lang="cs-CZ" altLang="ja-JP" sz="800" dirty="0">
              <a:latin typeface="Courier"/>
              <a:cs typeface="Courier"/>
            </a:endParaRPr>
          </a:p>
          <a:p>
            <a:r>
              <a:rPr lang="cs-CZ" altLang="ja-JP" sz="800" dirty="0">
                <a:latin typeface="Courier"/>
                <a:cs typeface="Courier"/>
              </a:rPr>
              <a:t>MdSSK1      71 QT-VKSFFQDEGVG--DMVMPLPN-VHSAELVNIIDFCTKTQHLHRKVEHDE------------------    118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1      53 QT-VKAFFQDESVAR-HMVMPVPN-VHSGELVKIIDFCTKSLDLNRKAEHEE------------------    10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2      65 ET-VKSFFQDEGVG--DMVMPVPN-VHSAELVKIIDFCTKTQHLHRKVEQDE------------------    112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SSK1     40 HT-VKAFFQDEGVSR-EMVMPILN-VNSAELVKIINFCTKTLELKRKADHEE------------------     88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PSK1     28 QT-IKHMVEDDCAD---NGIPLPN-VTSKILAKVIEYCKK-HVDAAKPDDRP------------------     73</a:t>
            </a:r>
          </a:p>
          <a:p>
            <a:r>
              <a:rPr lang="cs-CZ" altLang="ja-JP" sz="800" dirty="0">
                <a:latin typeface="Courier"/>
                <a:cs typeface="Courier"/>
              </a:rPr>
              <a:t>PiSSK1      29 EM-LKNMIEDDCAS---SVIPLPN-IDSKTLSKVIEYLNKHITRDEDEDEEQEESEDK------------     8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hSSK1      29 EM-LKNMIEDDCAS---SVIPLPN-IDSKTLSKVIEYLNKHITRDEDEDEEQEEGKDK------------     8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hSSK1      31 EM-IKNMVEDDCVT---TAIPIPV-VDSKTLAKVIVFLDKHGDS--------------------------     6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        27 QT-IAHMVEDDCVD---NGVPLPN-VTSKILAKVIEYCKR-HVEAAASKAEAVEGAA-------------     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        28 QT-IKHMIEDDCTD---NGIPLPN-VTSKILSKVIEYCKR-HVEAAEKSETTADAAAA------------     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3        29 QT-IKHMIEDDCVD---NGIPLPN-VTGAILAKVIEYCKKHVEAAAEAGGDKDFYGST------------     8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4        29 QT-IKHMIEDDCAD---NGIPLPN-VTGAILAKVIEYCKKHVEAAAEAGGDKDFYGSA------------     8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5        26 IA-INHMVEDGCAT---DVIPLRN-VTSKILKIVIDYCEKHVKS---KEE--------------------     6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6         6 ------MAEDDCAD---NGIPLPN-VTSKILLLVIEYCKKHVVE---SKE--------------------     4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7        27 QT-IAHMIEAECTD---NVIPVSN-VTSEILEMVIEYCNKHHVDAANP----------------------     6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8        27 QT-IAHMIEAECTD---NVILVLK-MTSEILEMVIEYCNKHHVDAANP----------------------     6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9        27 QIIIAHMSENDCTD---NGIPLPN-VTGKILAMVIEYCNKHHVDAANP----------------------     7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0       27 QT-IAHMSEDDCTD---NGIPLPE-VTGKILEMVIEYCNKHHVDAANP----------------------     6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1       27 QT-IAHMVEDDCVA---DGIPLAN-VESKILVKVIEYCKKHHVDEANP----------------------     6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2       27 QT-IAHMVEDDCVA---DGIPLAN-VESKILVKVIEYCKKYHVDEANP----------------------     6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3       26 QT-IAHMIEDDCVA---NGVPIAN-VTGVILSKVIEYCKKHVVSDSPTEESK------------------     7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4       27 KI-VEHMIEDDCVV---TEVPLQN-VTGKILSIVVEYCKKHVVD--------------------------     6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5       27 QI-VKHLLEDDCVI---NEIPLQN-VTGNILSIVLEYCKKHV---DDVVDDDAS--------EEPKKK--     7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6       27 KV-IAHMIDDDCAD---KAIPLEN-VTGNILALVIEYCKKHVL--DDVDDSDDST---------------     74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7       27 QM-VAHMIDDDCAD---KAIRLQN-VTGKILAIIIEYCKKHV---DDV----------------------     6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8       52 LI-IVHMMEDNCAG---EAIPLEN-VTGDILSKIIEYAKMHVNEPSEE----------------------     94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9       27 QI-VGHIIEDDCAT---NKIPIPN-VTGEILAKVIEYCKKHVEDDDDVVETHESSTKGDKTVEEAKKKPD     9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0       39 PMICQEVIQKGVGSSKNHAISLPQRVNPAMFSLILDYCRFHQLPGRSN----------------------     8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1       39 PMICQEVIQKGVGSSKNYAISLPQRVNPAMLSLIFDYCRFHQVPGRSN----------------------     86</a:t>
            </a:r>
          </a:p>
          <a:p>
            <a:r>
              <a:rPr lang="cs-CZ" altLang="ja-JP" sz="800" dirty="0">
                <a:latin typeface="Courier"/>
                <a:cs typeface="Courier"/>
              </a:rPr>
              <a:t>OSK1        31 QT-IRHMIEDDCAD---NGIPLPN-VNSKILSKVIEYCNK-HVHAAAAAASKAADDAA------------     82</a:t>
            </a:r>
          </a:p>
          <a:p>
            <a:r>
              <a:rPr lang="cs-CZ" altLang="ja-JP" sz="800" dirty="0">
                <a:latin typeface="Courier"/>
                <a:cs typeface="Courier"/>
              </a:rPr>
              <a:t>               .. . .. ....       ..... ... .. ...... ..                             </a:t>
            </a:r>
          </a:p>
          <a:p>
            <a:endParaRPr kumimoji="1" lang="ja-JP" altLang="en-US" sz="800" dirty="0">
              <a:latin typeface="Courier"/>
              <a:cs typeface="Courier"/>
            </a:endParaRPr>
          </a:p>
        </p:txBody>
      </p:sp>
    </p:spTree>
    <p:extLst>
      <p:ext uri="{BB962C8B-B14F-4D97-AF65-F5344CB8AC3E}">
        <p14:creationId xmlns:p14="http://schemas.microsoft.com/office/powerpoint/2010/main" val="14438379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4661" y="600624"/>
            <a:ext cx="5848677" cy="80945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cs-CZ" altLang="ja-JP" sz="800" dirty="0">
              <a:latin typeface="Courier"/>
              <a:cs typeface="Courier"/>
            </a:endParaRPr>
          </a:p>
          <a:p>
            <a:r>
              <a:rPr lang="cs-CZ" altLang="ja-JP" sz="800" dirty="0">
                <a:latin typeface="Courier"/>
                <a:cs typeface="Courier"/>
              </a:rPr>
              <a:t>MdSSK1     119 ---------------AWRKELRKISTDFVRELTTD-RVMELILAADFLHVDLLLEVLNQTVAD-----RI    16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1     102 ---------------VSKKELRKFNNDFVKDETTG-NVMELTLAADYLNVDQMLEVLNQCVAD-----RI    150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2     113 ---------------AWRKELRKISTDFVRELTTD-SVMELILAADFLHVDLLLEVLNQTVAD-----RI    16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SSK1     89 ---------------NAKKELRLFYKDFVKDETTE-HIMELILAADYLHVDDLLEVLNQCVAD-----RI    13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PSK1     74 ---------------SNDEDLKAWDTDFVK-IDQA-TLFDLILAANYLNIKSLLDLTCQTVAD-----MI    12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iSSK1      82 ---------GKEVDTGEEDDLKEFDEQFVN-VGFE-ELFDIIMAANYLNIHELMELCCQSAAD-----RL    135</a:t>
            </a:r>
          </a:p>
          <a:p>
            <a:r>
              <a:rPr lang="cs-CZ" altLang="ja-JP" sz="800" dirty="0">
                <a:latin typeface="Courier"/>
                <a:cs typeface="Courier"/>
              </a:rPr>
              <a:t>PhSSK1      82 ---------GKEVDTGEEDDLKEFDEQFVN-VGFE-ELFDIIMAANYLNIHELMELCCQSAAD-----RL    13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hSSK1      70 --------------TISSDDMKKFDEEYVTGVEMG-ILFDLAAAANYLNIKDMMEVVTQKIAD-----IM    11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        78 ---------------TSDDDLKAWDADFMK-IDQA-TLFELILAANYLNIKNLLDLTCQTVAD-----MI    12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        80 ------TTTTTVASGSSDEDLKTWDSEFIK-VDQG-TLFDLILAANYLNIKGLLDLTCQTVAD-----MI    136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3        82 ----------------ENHELKTWDNDFVKVDHPT--LFDLLRAANYLNISGLLDLTCKAVAD-----QM    12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4        82 ----------------ENDELKNWDSEFVKVDQPT--LFDLILAANYLNIGGLLDLTCKAVAD-----QM    12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5        68 ------------------EDLKEWDADFMKTIETT-ILFDVMMAANYLNIQSLLDLTCKTVSDLLQADLL    11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6        43 ------------------EDLKKWDAEFMKKMEQS-ILFDVMMAANYLNIQSLLDLTFSNCR--------     8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7        70 ---------------CSDEDLKKWDKEFME-KDQY-TIFHLMNAAYDLHIKSLLALAYQTVAD-----MV    11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8        70 ---------------CSDDDLEKWDKEFME-KDKS-TIFALTNAANFLNNKSLLHLAGQTVAD-----MI    11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9        71 ---------------CSDDDLKKWDKEFME-KDTS-TIFDLIKAANYLNIKSLFDLACQTVAE-----II    118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0       70 ---------------CSDEDLKKWDKEFME-KYQS-TIFDLIMAANYLNIKSLLDLACQTVAD-----MI    11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1       70 ---------------ISEEDLNNWDEKFMD-LEQS-TIFELILAANYLNIKSLLDLTCQTVAD-----MI    11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2       70 ---------------ISEEDLNKWDEKFMD-LEQS-TIFELILAANYLNIKSLFDLTCQTVAD-----MI    11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3       73 ------------------DELKKWDAEFMKALEQSSTLFDVMLAANYLNIKDLLDLGCQTVAD-----MI    11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4       66 ---------------EESDEFKTWDEEFMKKFDQP-TVFQLLLAANYLNIKGLLDLSAQTVAD-----RI    114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5       79 --------KPDDEA---KQNLDAWDAEFMKNIDME-TIFKLILAANYLNVEGLLGLTCQTVAD-----YI    13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6       75 ------EATSENVNEEAKNELRTWDAEFMKEFDME-TVMKLILAVNYLNVQDLLGLTCQTVAD-----HM    13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7       67 ---------------EAKNEFVTWDAEFVKNIDMD-TLFKLLDAADYLIVIGLKNLIAQAIAD-----YT    11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8       95 -----------DEDEEAKKNLDSWDAKFMEKLDLE-TIFKIILAANYLNFEGLLGFASQTVAD-----YI    14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9       92 DVAVPESTEGDDEAEDKKEKLNEWDAKFMKDFDIK-TIFDIILAANYLNVQGLFDLCSKTIAD-----YI    15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0       87 ------------------KERKTYDERFIRMDTKR--LCELTSAADSLQLKPLVDLTSRALAR-----II    13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1       87 ------------------KERKVYDEKFIRMDTKR--LCELTSAADSLQLKPLVDLTSRALAR-----II    131</a:t>
            </a:r>
          </a:p>
          <a:p>
            <a:r>
              <a:rPr lang="cs-CZ" altLang="ja-JP" sz="800" dirty="0">
                <a:latin typeface="Courier"/>
                <a:cs typeface="Courier"/>
              </a:rPr>
              <a:t>OSK1        83 ------SAAAAVPP-PSGEDLKNWDADFVK-VDQA-TLFDLILAANYLNIKGLLDLTCQTVAD-----MI    138</a:t>
            </a:r>
          </a:p>
          <a:p>
            <a:r>
              <a:rPr lang="cs-CZ" altLang="ja-JP" sz="800" dirty="0">
                <a:latin typeface="Courier"/>
                <a:cs typeface="Courier"/>
              </a:rPr>
              <a:t>                                   .. ..  . .      . . ...*...*..  .... ......      .</a:t>
            </a:r>
          </a:p>
          <a:p>
            <a:endParaRPr lang="cs-CZ" altLang="ja-JP" sz="800" dirty="0">
              <a:latin typeface="Courier"/>
              <a:cs typeface="Courier"/>
            </a:endParaRPr>
          </a:p>
          <a:p>
            <a:r>
              <a:rPr lang="cs-CZ" altLang="ja-JP" sz="800" dirty="0">
                <a:latin typeface="Courier"/>
                <a:cs typeface="Courier"/>
              </a:rPr>
              <a:t>MdSSK1     168 KNKSVEHVRKLFGVESDYTPEEEQ------------------------KLREEYAWAFEGVDED------    20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1     151 KNKSVEYVRQLFGVESDFTPEEEQ------------------------KLRDEYAWAFEGVDED------    190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2     162 KNKSVEYVRKLFGVESDYTPEEEQ------------------------KLREEYAWAFEGVDED------    20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SSK1    138 KNKSVEYVRKLFGVENDFTPEEEQ------------------------KLREEYAWAFEGVDED------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PSK1    122 KGKTPEEIRKTFNIKNDFTPEEEE------------------------EVRRENQWAFE-----------    156</a:t>
            </a:r>
          </a:p>
          <a:p>
            <a:r>
              <a:rPr lang="cs-CZ" altLang="ja-JP" sz="800" dirty="0">
                <a:latin typeface="Courier"/>
                <a:cs typeface="Courier"/>
              </a:rPr>
              <a:t>PiSSK1     136 KNKSVRAVREMLKITNDLTEEEEQ------------------------EIINDAPWAFEGPEIDDTVN--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PhSSK1     136 KNKSVRAVREMLKITNDLTEEEEQ------------------------EIINDAPWAFEGPEIDDTVN--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hSSK1     120 ENKSVAWVRKTFGIENDLDPEEEK------------------------ALQDEYPWAFEGLDPDSD----    16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       126 KGKTPEEIRTTFNIKNDFTPEEEE------------------------EVRRENQWAFE-----------    16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       137 KGKTPEEIRKTFNIKNDFTPEEEE------------------------EVRRENQWAFE-----------    17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3       129 RGKTPAQMREHFNIKNDYTPEEEA------------------------EVRNENRWAFE-----------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4       129 RGKTPEQMRAHFNIKNDYTPEEEA------------------------EVRNENKWAFE-----------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5       119 SGKTPDEIRAHFNIENDLTAEEVA------------------------KIREENQWAFQ-----------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6        86 ----------------------------------------------------------------------     8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7       118 N---------------------------------------------------DNKWAFE-----------    12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8       118 KGNTPKQMREFFNIENDLTPEEEA------------------------AIRRENKWAFE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9       119 KGNTPEQIREFFNIENDLTPEEEA------------------------AIRRENKWAFE-----------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0      118 KDNTVEHTRKFFNIENDYTHEEEE------------------------AVRRENQWGFE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1      118 KGKTPEEIRSTFNIENDFTPEEEE------------------------AVRKENQWAFE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2      118 KGKTPEEIRSTFNIENDFTPEEEE------------------------AVRKENQWAFE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3      120 TGKKPDEIRALLGIENDFTPEEEE------------------------EIRKENQWAFE-----------    154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4      115 KDKTPEEIREIFNIENDFTPEEEA------------------------AVRKENAWAFE-----------    14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5      132 KDKTPEEVRELFNIENDFTHEEEEE-----------------------AIRKENAWAFEADTKHEDPKP-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6      133 KDMSPEEVRELFNIENDYTPEEED------------------------AIRKENAWAFEDLK--------    17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7      116 ADKTVNEIRELFNIENDYTPEEEE------------------------ELRKKNEWAFN-----------    15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8      148 KDKTPEEVREIFNIENDFTPEEEE------------------------EIRKENAWTFNE----------    18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9      156 KDMTPEEVRELFNIENDFTPEEEE------------------------AIRNENAWTFEQDGKQQVPKP-    20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0      132 EGKNPEEIREIFHLPDDLTEEEKLEPLKNSMDDPRIRLLNRLYAKKRKELKERERLKNVEVEEHVDERSV    20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1      132 EGKTPEEIREIFHLPDDLTEEEKLEPLKNTMDDPRIRLLNRLYAKKRKELKEREKLKSVEVEEHVDERSV    201</a:t>
            </a:r>
          </a:p>
          <a:p>
            <a:r>
              <a:rPr lang="cs-CZ" altLang="ja-JP" sz="800" dirty="0">
                <a:latin typeface="Courier"/>
                <a:cs typeface="Courier"/>
              </a:rPr>
              <a:t>OSK1       139 KGKTPEEIRKTFNIKNDFTPEEEE------------------------EIRRENQWAFE-----------    173</a:t>
            </a:r>
          </a:p>
          <a:p>
            <a:r>
              <a:rPr lang="cs-CZ" altLang="ja-JP" sz="800" dirty="0">
                <a:latin typeface="Courier"/>
                <a:cs typeface="Courier"/>
              </a:rPr>
              <a:t>               . ..... .  ...... .....                           . .. ....           </a:t>
            </a:r>
          </a:p>
          <a:p>
            <a:endParaRPr lang="cs-CZ" altLang="ja-JP" sz="800" dirty="0">
              <a:latin typeface="Courier"/>
              <a:cs typeface="Courier"/>
            </a:endParaRPr>
          </a:p>
        </p:txBody>
      </p:sp>
    </p:spTree>
    <p:extLst>
      <p:ext uri="{BB962C8B-B14F-4D97-AF65-F5344CB8AC3E}">
        <p14:creationId xmlns:p14="http://schemas.microsoft.com/office/powerpoint/2010/main" val="38685598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497672" y="686427"/>
            <a:ext cx="5848677" cy="78483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altLang="ja-JP" sz="800" dirty="0">
                <a:latin typeface="Courier"/>
                <a:cs typeface="Courier"/>
              </a:rPr>
              <a:t>MdSSK1     208 ----------------------------------------------------------------------    20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1     191 ----------------------------------------------------------------------    190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2     202 ----------------------------------------------------------------------    20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SSK1    178 ----------------------------------------------------------------------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PSK1    157 ----------------------------------------------------------------------    156</a:t>
            </a:r>
          </a:p>
          <a:p>
            <a:r>
              <a:rPr lang="cs-CZ" altLang="ja-JP" sz="800" dirty="0">
                <a:latin typeface="Courier"/>
                <a:cs typeface="Courier"/>
              </a:rPr>
              <a:t>PiSSK1     180 ----------------------------------------------------------------------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PhSSK1     180 ----------------------------------------------------------------------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hSSK1     162 ----------------------------------------------------------------------    16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       161 ----------------------------------------------------------------------    16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       172 ----------------------------------------------------------------------    17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3       164 ----------------------------------------------------------------------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4       164 ----------------------------------------------------------------------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5       154 ----------------------------------------------------------------------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6        86 ----------------------------------------------------------------------     8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7       126 ----------------------------------------------------------------------    12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8 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9       154 ----------------------------------------------------------------------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0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1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2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3      155 ----------------------------------------------------------------------    154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4      150 ----------------------------------------------------------------------    14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5      178 ----------------------------------------------------------------------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6      171 ----------------------------------------------------------------------    17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7      151 ----------------------------------------------------------------------    15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8      184 ----------------------------------------------------------------------    18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9      201 ----------------------------------------------------------------------    20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0      202 DDLLSFINGRDHKAVKMSKGKKKKKKKKDQKIVSSN---NIHDKESHDLRSKQQCVEEIG---SSMREVP    26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1      202 DDLLSFINGRDPKVVKTSKSKKKNKKRKEQKNGSSNGTCEALEKDLHNLDSKSQSAEIVDNTASCLGDVS    271</a:t>
            </a:r>
          </a:p>
          <a:p>
            <a:r>
              <a:rPr lang="cs-CZ" altLang="ja-JP" sz="800" dirty="0">
                <a:latin typeface="Courier"/>
                <a:cs typeface="Courier"/>
              </a:rPr>
              <a:t>OSK1       174 ----------------------------------------------------------------------    173</a:t>
            </a:r>
          </a:p>
          <a:p>
            <a:r>
              <a:rPr lang="cs-CZ" altLang="ja-JP" sz="800" dirty="0">
                <a:latin typeface="Courier"/>
                <a:cs typeface="Courier"/>
              </a:rPr>
              <a:t>                                                                                     </a:t>
            </a:r>
          </a:p>
          <a:p>
            <a:endParaRPr lang="cs-CZ" altLang="ja-JP" sz="800" dirty="0">
              <a:latin typeface="Courier"/>
              <a:cs typeface="Courier"/>
            </a:endParaRPr>
          </a:p>
          <a:p>
            <a:r>
              <a:rPr lang="cs-CZ" altLang="ja-JP" sz="800" dirty="0">
                <a:latin typeface="Courier"/>
                <a:cs typeface="Courier"/>
              </a:rPr>
              <a:t>MdSSK1     208 ----------------------------------------------------------------------    20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1     191 ----------------------------------------------------------------------    190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2     202 ----------------------------------------------------------------------    20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SSK1    178 ----------------------------------------------------------------------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PSK1    157 ----------------------------------------------------------------------    156</a:t>
            </a:r>
          </a:p>
          <a:p>
            <a:r>
              <a:rPr lang="cs-CZ" altLang="ja-JP" sz="800" dirty="0">
                <a:latin typeface="Courier"/>
                <a:cs typeface="Courier"/>
              </a:rPr>
              <a:t>PiSSK1     180 ----------------------------------------------------------------------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PhSSK1     180 ----------------------------------------------------------------------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hSSK1     162 ----------------------------------------------------------------------    16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       161 ----------------------------------------------------------------------    16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       172 ----------------------------------------------------------------------    17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3       164 ----------------------------------------------------------------------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4       164 ----------------------------------------------------------------------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5       154 ----------------------------------------------------------------------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6        86 ----------------------------------------------------------------------     8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7       126 ----------------------------------------------------------------------    12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8 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9       154 ----------------------------------------------------------------------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0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1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2      153 ----------------------------------------------------------------------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3      155 ----------------------------------------------------------------------    154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4      150 ----------------------------------------------------------------------    14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5      178 ----------------------------------------------------------------------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6      171 ----------------------------------------------------------------------    17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7      151 ----------------------------------------------------------------------    15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8      184 ----------------------------------------------------------------------    18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9      201 ----------------------------------------------------------------------    20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0      266 NLLSAEDDISTPNAGSEDEDIDDEIDPAMRELLDREVEDFAQRLNSNWVRSLGKERRPVHFSINGNGTTR    33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1      272 NLPSMEDDIFTPKTEFEDGYIDDEIDPALKELLDREVEDFARRLNSSWVLSIGQERQPVNFSINGNGTSR    341</a:t>
            </a:r>
          </a:p>
          <a:p>
            <a:r>
              <a:rPr lang="cs-CZ" altLang="ja-JP" sz="800" dirty="0">
                <a:latin typeface="Courier"/>
                <a:cs typeface="Courier"/>
              </a:rPr>
              <a:t>OSK1       174 ----------------------------------------------------------------------    173</a:t>
            </a:r>
          </a:p>
          <a:p>
            <a:r>
              <a:rPr lang="cs-CZ" altLang="ja-JP" sz="800" dirty="0">
                <a:latin typeface="Courier"/>
                <a:cs typeface="Courier"/>
              </a:rPr>
              <a:t>                                                     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11814800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4661" y="738745"/>
            <a:ext cx="5848677" cy="42780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cs-CZ" altLang="ja-JP" sz="800" dirty="0">
              <a:latin typeface="Courier"/>
              <a:cs typeface="Courier"/>
            </a:endParaRPr>
          </a:p>
          <a:p>
            <a:r>
              <a:rPr lang="cs-CZ" altLang="ja-JP" sz="800" dirty="0">
                <a:latin typeface="Courier"/>
                <a:cs typeface="Courier"/>
              </a:rPr>
              <a:t>MdSSK1     208 ----------                                                                20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1     191 ----------                                                                190</a:t>
            </a:r>
          </a:p>
          <a:p>
            <a:r>
              <a:rPr lang="cs-CZ" altLang="ja-JP" sz="800" dirty="0">
                <a:latin typeface="Courier"/>
                <a:cs typeface="Courier"/>
              </a:rPr>
              <a:t>PbSSK2     202 ----------                                                                201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SSK1    178 ----------                                                            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PavPSK1    157 ----------                                                                156</a:t>
            </a:r>
          </a:p>
          <a:p>
            <a:r>
              <a:rPr lang="cs-CZ" altLang="ja-JP" sz="800" dirty="0">
                <a:latin typeface="Courier"/>
                <a:cs typeface="Courier"/>
              </a:rPr>
              <a:t>PiSSK1     180 ----------                                                            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PhSSK1     180 ----------                                                                17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hSSK1     162 ----------                                                                16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       161 ----------                                                                16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       172 ----------                                                                171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3       164 ----------                                                            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4       164 ----------                                                                16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5       154 ----------                                                            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6        86 ----------                                                                 8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7       126 ----------                                                                125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8       153 ----------                                                            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9       154 ----------                                                                15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0      153 ----------                                                            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1      153 ----------                                                            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2      153 ----------                                                                15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3      155 ----------                                                                154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4      150 ----------                                                                149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5      178 ----------                                                                177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6      171 ----------                                                                17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7      151 ----------                                                                15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8      184 ----------                                                                183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19      201 ----------                                                                200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0      336 RHTGQSP---                                                                342</a:t>
            </a:r>
          </a:p>
          <a:p>
            <a:r>
              <a:rPr lang="cs-CZ" altLang="ja-JP" sz="800" dirty="0">
                <a:latin typeface="Courier"/>
                <a:cs typeface="Courier"/>
              </a:rPr>
              <a:t>ASK21      342 RLTGPAAGHK                                                                351</a:t>
            </a:r>
          </a:p>
          <a:p>
            <a:r>
              <a:rPr lang="cs-CZ" altLang="ja-JP" sz="800" dirty="0">
                <a:latin typeface="Courier"/>
                <a:cs typeface="Courier"/>
              </a:rPr>
              <a:t>OSK1       174 ----------                                                                173</a:t>
            </a:r>
          </a:p>
          <a:p>
            <a:endParaRPr lang="ja-JP" altLang="en-US" sz="800" dirty="0"/>
          </a:p>
          <a:p>
            <a:endParaRPr lang="ja-JP" altLang="en-US" sz="800" dirty="0"/>
          </a:p>
          <a:p>
            <a:endParaRPr kumimoji="1" lang="ja-JP" altLang="en-US" sz="800" dirty="0"/>
          </a:p>
        </p:txBody>
      </p:sp>
    </p:spTree>
    <p:extLst>
      <p:ext uri="{BB962C8B-B14F-4D97-AF65-F5344CB8AC3E}">
        <p14:creationId xmlns:p14="http://schemas.microsoft.com/office/powerpoint/2010/main" val="102408171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1</TotalTime>
  <Words>8702</Words>
  <Application>Microsoft Macintosh PowerPoint</Application>
  <PresentationFormat>A4 210x297 mm</PresentationFormat>
  <Paragraphs>222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南川 舞</dc:creator>
  <cp:lastModifiedBy>南川 舞</cp:lastModifiedBy>
  <cp:revision>83</cp:revision>
  <cp:lastPrinted>2014-01-17T05:56:58Z</cp:lastPrinted>
  <dcterms:created xsi:type="dcterms:W3CDTF">2013-11-20T09:12:09Z</dcterms:created>
  <dcterms:modified xsi:type="dcterms:W3CDTF">2014-01-29T06:00:31Z</dcterms:modified>
</cp:coreProperties>
</file>